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" initials="B" lastIdx="1" clrIdx="0"/>
  <p:cmAuthor id="1" name="Tuchscherr de Hauschopp, Lorena" initials="TdH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598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26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1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14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375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80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6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39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07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5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55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22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23528" y="35496"/>
            <a:ext cx="64898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Supporting Information Fig.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1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rowth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urves, mean generation times (MTGs) and hemolytic activities of bacterial strain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7259" y="899592"/>
            <a:ext cx="4336256" cy="2321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feld 8"/>
          <p:cNvSpPr txBox="1"/>
          <p:nvPr/>
        </p:nvSpPr>
        <p:spPr>
          <a:xfrm>
            <a:off x="476672" y="75557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8564" y="3419872"/>
            <a:ext cx="4086225" cy="2321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feld 6"/>
          <p:cNvSpPr txBox="1"/>
          <p:nvPr/>
        </p:nvSpPr>
        <p:spPr>
          <a:xfrm>
            <a:off x="488547" y="334786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5783571"/>
            <a:ext cx="6460241" cy="16561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02411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476672" y="611560"/>
            <a:ext cx="5598823" cy="2955902"/>
            <a:chOff x="476672" y="611560"/>
            <a:chExt cx="5598823" cy="2955902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5151" y="1041426"/>
              <a:ext cx="2750344" cy="23360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122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672" y="1052862"/>
              <a:ext cx="2750344" cy="2514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feld 1"/>
            <p:cNvSpPr txBox="1"/>
            <p:nvPr/>
          </p:nvSpPr>
          <p:spPr>
            <a:xfrm>
              <a:off x="476672" y="611560"/>
              <a:ext cx="15424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: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molytic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vity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1624174" y="1944961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1788449" y="1883611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1952589" y="2049861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2099396" y="2049861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2276246" y="205172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2433653" y="2039845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2948068" y="2085486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feld 2"/>
            <p:cNvSpPr txBox="1"/>
            <p:nvPr/>
          </p:nvSpPr>
          <p:spPr>
            <a:xfrm>
              <a:off x="2075533" y="894075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S1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5130651" y="2036011"/>
              <a:ext cx="6447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itchFamily="34" charset="0"/>
                  <a:cs typeface="Arial" pitchFamily="34" charset="0"/>
                </a:rPr>
                <a:t>*   *  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4690398" y="887717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1000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6544792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Bildschirmpräsentation (4:3)</PresentationFormat>
  <Paragraphs>14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73</cp:revision>
  <cp:lastPrinted>2015-02-05T15:03:15Z</cp:lastPrinted>
  <dcterms:created xsi:type="dcterms:W3CDTF">2014-11-04T10:41:58Z</dcterms:created>
  <dcterms:modified xsi:type="dcterms:W3CDTF">2015-04-13T07:28:01Z</dcterms:modified>
</cp:coreProperties>
</file>